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CF323-1807-4A23-B1DB-EB4E845268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925897-F1D1-4A25-9096-8D0788BF5C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9B234C-2A25-4F03-8586-D976F73363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61002C-EA1D-4781-82C8-C66E12A85E1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BE1762-FF1A-4B0D-BB46-C90330BC9F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656017-C493-4EF7-81F6-9365AAEBDF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CE671B-420E-4772-895C-99C7D3DF54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A3CCC3-A5E8-426F-B7D9-E2BDA0FBFB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B0EBAE-A6DB-4243-8D78-AB5B6955BF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66CEE7-8C54-4048-B3A6-4A5F93D18B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989F5A-61F5-40BA-B57D-1C70DC92EB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6A36D0-B52B-4C67-BB9A-2A32FC4068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A450A2-139B-4215-8BE5-390808F9B738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0" y="7696080"/>
            <a:ext cx="68580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5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. crus-galli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hloroplast genome structure and annotation. Outer circle: The genes shown outside of the circle are transcribed clockwise, whereas those inside are transcribed counterclockwise; Inner circle: the genomic structure with two inverted repeats (IR) and two single copy regions (LSC and SSC). Genes belonging to different functional groups are color cod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2" descr="G:\F\B_ZhejiangUniversity\稗草叶绿体\v7\提交\GenomeVx3_BTS02_包含假基因.tif"/>
          <p:cNvPicPr/>
          <p:nvPr/>
        </p:nvPicPr>
        <p:blipFill>
          <a:blip r:embed="rId1"/>
          <a:stretch/>
        </p:blipFill>
        <p:spPr>
          <a:xfrm>
            <a:off x="304920" y="76320"/>
            <a:ext cx="6476760" cy="6476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1T04:17:23Z</dcterms:created>
  <dc:creator>Chuyu YE</dc:creator>
  <dc:description/>
  <dc:language>en-US</dc:language>
  <cp:lastModifiedBy>user</cp:lastModifiedBy>
  <dcterms:modified xsi:type="dcterms:W3CDTF">2014-11-01T04:18:50Z</dcterms:modified>
  <cp:revision>4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